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62" d="100"/>
          <a:sy n="62" d="100"/>
        </p:scale>
        <p:origin x="2010" y="39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3F045-019E-43BB-85A7-78A87C3B7932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2938D-EFD2-4FDB-B4EF-0E2392EA04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654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3F045-019E-43BB-85A7-78A87C3B7932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2938D-EFD2-4FDB-B4EF-0E2392EA04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19667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3F045-019E-43BB-85A7-78A87C3B7932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2938D-EFD2-4FDB-B4EF-0E2392EA04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9208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3F045-019E-43BB-85A7-78A87C3B7932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2938D-EFD2-4FDB-B4EF-0E2392EA04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8661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3F045-019E-43BB-85A7-78A87C3B7932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2938D-EFD2-4FDB-B4EF-0E2392EA04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1285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3F045-019E-43BB-85A7-78A87C3B7932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2938D-EFD2-4FDB-B4EF-0E2392EA04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0986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3F045-019E-43BB-85A7-78A87C3B7932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2938D-EFD2-4FDB-B4EF-0E2392EA04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8716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3F045-019E-43BB-85A7-78A87C3B7932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2938D-EFD2-4FDB-B4EF-0E2392EA04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9030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3F045-019E-43BB-85A7-78A87C3B7932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2938D-EFD2-4FDB-B4EF-0E2392EA04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8192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3F045-019E-43BB-85A7-78A87C3B7932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2938D-EFD2-4FDB-B4EF-0E2392EA04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31664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3F045-019E-43BB-85A7-78A87C3B7932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2938D-EFD2-4FDB-B4EF-0E2392EA04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45572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73F045-019E-43BB-85A7-78A87C3B7932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22938D-EFD2-4FDB-B4EF-0E2392EA04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5873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2B2E939-B188-61FF-410A-6DD74A96EBB2}"/>
              </a:ext>
            </a:extLst>
          </p:cNvPr>
          <p:cNvSpPr txBox="1"/>
          <p:nvPr/>
        </p:nvSpPr>
        <p:spPr>
          <a:xfrm>
            <a:off x="1420543" y="970072"/>
            <a:ext cx="3508780" cy="31495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GB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ir</a:t>
            </a: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= </a:t>
            </a:r>
            <a:r>
              <a:rPr lang="en-GB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etDirectory</a:t>
            </a: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"Where to save the profiles?");</a:t>
            </a:r>
            <a:endParaRPr lang="en-GB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GB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etSelectionBounds</a:t>
            </a: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 x, y, w, h );</a:t>
            </a:r>
            <a:endParaRPr lang="en-GB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( </a:t>
            </a:r>
            <a:r>
              <a:rPr lang="en-GB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</a:t>
            </a: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; </a:t>
            </a:r>
            <a:r>
              <a:rPr lang="en-GB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</a:t>
            </a: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&lt;w; </a:t>
            </a:r>
            <a:r>
              <a:rPr lang="en-GB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</a:t>
            </a: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+= 50 ) {</a:t>
            </a:r>
            <a:endParaRPr lang="en-GB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       </a:t>
            </a:r>
            <a:r>
              <a:rPr lang="en-GB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keLine</a:t>
            </a: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 </a:t>
            </a:r>
            <a:r>
              <a:rPr lang="en-GB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x+i</a:t>
            </a: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y, </a:t>
            </a:r>
            <a:r>
              <a:rPr lang="en-GB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x+i</a:t>
            </a: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y+h-1 );</a:t>
            </a:r>
            <a:endParaRPr lang="en-GB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       p = </a:t>
            </a:r>
            <a:r>
              <a:rPr lang="en-GB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etProfile</a:t>
            </a: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);</a:t>
            </a:r>
            <a:endParaRPr lang="en-GB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       t = "";</a:t>
            </a:r>
            <a:endParaRPr lang="en-GB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       for (k=0; k&lt;</a:t>
            </a:r>
            <a:r>
              <a:rPr lang="en-GB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.length</a:t>
            </a: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k++) {</a:t>
            </a:r>
            <a:endParaRPr lang="en-GB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              t += "" + k + "\t" + p[k] + "\n";</a:t>
            </a:r>
            <a:endParaRPr lang="en-GB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       }</a:t>
            </a:r>
            <a:endParaRPr lang="en-GB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       </a:t>
            </a:r>
            <a:r>
              <a:rPr lang="en-GB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le.saveString</a:t>
            </a: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 t, </a:t>
            </a:r>
            <a:r>
              <a:rPr lang="en-GB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ir</a:t>
            </a: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+ "x" + </a:t>
            </a:r>
            <a:r>
              <a:rPr lang="en-GB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</a:t>
            </a: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+ ".txt" );</a:t>
            </a:r>
            <a:endParaRPr lang="en-GB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500"/>
              </a:spcAft>
            </a:pPr>
            <a:r>
              <a:rPr lang="en-GB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}</a:t>
            </a:r>
            <a:endParaRPr lang="en-GB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0C8B727-FB7E-DDB5-1B7A-2B2F060A8A19}"/>
              </a:ext>
            </a:extLst>
          </p:cNvPr>
          <p:cNvSpPr txBox="1"/>
          <p:nvPr/>
        </p:nvSpPr>
        <p:spPr>
          <a:xfrm>
            <a:off x="368300" y="4263234"/>
            <a:ext cx="6489700" cy="5770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05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1. Macro for measuring tight junctions from </a:t>
            </a:r>
            <a:r>
              <a:rPr lang="en-GB" sz="105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Fiji ImageJ.</a:t>
            </a:r>
          </a:p>
          <a:p>
            <a:pPr algn="just"/>
            <a:r>
              <a:rPr lang="en-GB" sz="1050" b="0" i="0" dirty="0" err="1">
                <a:solidFill>
                  <a:srgbClr val="202124"/>
                </a:solidFill>
                <a:effectLst/>
                <a:latin typeface="arial" panose="020B0604020202020204" pitchFamily="34" charset="0"/>
              </a:rPr>
              <a:t>Rasband</a:t>
            </a:r>
            <a:r>
              <a:rPr lang="en-GB" sz="1050" b="0" i="0" dirty="0">
                <a:solidFill>
                  <a:srgbClr val="202124"/>
                </a:solidFill>
                <a:effectLst/>
                <a:latin typeface="arial" panose="020B0604020202020204" pitchFamily="34" charset="0"/>
              </a:rPr>
              <a:t>, W.S., ImageJ, U. S. National Institutes of Health, Bethesda, Maryland, USA, https://imagej.nih.gov/ij/, 1997-2018.</a:t>
            </a:r>
            <a:r>
              <a:rPr lang="en-GB" sz="105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endParaRPr lang="en-GB" sz="1050" b="1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6BFDE58-FF29-66B8-D75B-26B3C6888FDA}"/>
              </a:ext>
            </a:extLst>
          </p:cNvPr>
          <p:cNvSpPr txBox="1"/>
          <p:nvPr/>
        </p:nvSpPr>
        <p:spPr>
          <a:xfrm>
            <a:off x="368300" y="330200"/>
            <a:ext cx="2104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 1</a:t>
            </a:r>
          </a:p>
        </p:txBody>
      </p:sp>
    </p:spTree>
    <p:extLst>
      <p:ext uri="{BB962C8B-B14F-4D97-AF65-F5344CB8AC3E}">
        <p14:creationId xmlns:p14="http://schemas.microsoft.com/office/powerpoint/2010/main" val="12662788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8</Words>
  <Application>Microsoft Office PowerPoint</Application>
  <PresentationFormat>A4 Paper (210x297 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meljit Kalsi</dc:creator>
  <cp:lastModifiedBy>Kameljit Kalsi</cp:lastModifiedBy>
  <cp:revision>1</cp:revision>
  <dcterms:created xsi:type="dcterms:W3CDTF">2022-06-02T11:15:54Z</dcterms:created>
  <dcterms:modified xsi:type="dcterms:W3CDTF">2023-06-13T11:36:40Z</dcterms:modified>
</cp:coreProperties>
</file>